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sldIdLst>
    <p:sldId id="256" r:id="rId5"/>
  </p:sldIdLst>
  <p:sldSz cx="4679950" cy="3959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91" autoAdjust="0"/>
    <p:restoredTop sz="94660"/>
  </p:normalViewPr>
  <p:slideViewPr>
    <p:cSldViewPr snapToGrid="0">
      <p:cViewPr varScale="1">
        <p:scale>
          <a:sx n="213" d="100"/>
          <a:sy n="213" d="100"/>
        </p:scale>
        <p:origin x="183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xime GOLIAS" userId="1d0107c23b74f3ca" providerId="LiveId" clId="{8C31D4A3-5C85-4DFA-BE7A-99CD205A5F62}"/>
    <pc:docChg chg="custSel delSld modSld">
      <pc:chgData name="Maxime GOLIAS" userId="1d0107c23b74f3ca" providerId="LiveId" clId="{8C31D4A3-5C85-4DFA-BE7A-99CD205A5F62}" dt="2025-11-27T11:14:07.172" v="70" actId="1038"/>
      <pc:docMkLst>
        <pc:docMk/>
      </pc:docMkLst>
      <pc:sldChg chg="addSp delSp modSp mod">
        <pc:chgData name="Maxime GOLIAS" userId="1d0107c23b74f3ca" providerId="LiveId" clId="{8C31D4A3-5C85-4DFA-BE7A-99CD205A5F62}" dt="2025-11-27T11:14:07.172" v="70" actId="1038"/>
        <pc:sldMkLst>
          <pc:docMk/>
          <pc:sldMk cId="3892590946" sldId="256"/>
        </pc:sldMkLst>
        <pc:spChg chg="mod">
          <ac:chgData name="Maxime GOLIAS" userId="1d0107c23b74f3ca" providerId="LiveId" clId="{8C31D4A3-5C85-4DFA-BE7A-99CD205A5F62}" dt="2025-11-27T11:13:48.629" v="66" actId="1076"/>
          <ac:spMkLst>
            <pc:docMk/>
            <pc:sldMk cId="3892590946" sldId="256"/>
            <ac:spMk id="2" creationId="{CAD8B20A-28B9-4A9D-BE62-1C3A9CE9FFB2}"/>
          </ac:spMkLst>
        </pc:spChg>
        <pc:spChg chg="del">
          <ac:chgData name="Maxime GOLIAS" userId="1d0107c23b74f3ca" providerId="LiveId" clId="{8C31D4A3-5C85-4DFA-BE7A-99CD205A5F62}" dt="2025-11-27T11:11:43.547" v="2" actId="478"/>
          <ac:spMkLst>
            <pc:docMk/>
            <pc:sldMk cId="3892590946" sldId="256"/>
            <ac:spMk id="3" creationId="{C3A59D53-A73F-4C7C-9709-B98E0FB7B64C}"/>
          </ac:spMkLst>
        </pc:spChg>
        <pc:spChg chg="mod">
          <ac:chgData name="Maxime GOLIAS" userId="1d0107c23b74f3ca" providerId="LiveId" clId="{8C31D4A3-5C85-4DFA-BE7A-99CD205A5F62}" dt="2025-11-27T11:13:45.922" v="65" actId="1076"/>
          <ac:spMkLst>
            <pc:docMk/>
            <pc:sldMk cId="3892590946" sldId="256"/>
            <ac:spMk id="6" creationId="{1246733A-404E-4BD2-B29E-642B643F394C}"/>
          </ac:spMkLst>
        </pc:spChg>
        <pc:spChg chg="mod">
          <ac:chgData name="Maxime GOLIAS" userId="1d0107c23b74f3ca" providerId="LiveId" clId="{8C31D4A3-5C85-4DFA-BE7A-99CD205A5F62}" dt="2025-11-27T11:13:42.409" v="64" actId="404"/>
          <ac:spMkLst>
            <pc:docMk/>
            <pc:sldMk cId="3892590946" sldId="256"/>
            <ac:spMk id="9" creationId="{0346B0A7-A77F-460C-BD63-556881882CCE}"/>
          </ac:spMkLst>
        </pc:spChg>
        <pc:spChg chg="add mod">
          <ac:chgData name="Maxime GOLIAS" userId="1d0107c23b74f3ca" providerId="LiveId" clId="{8C31D4A3-5C85-4DFA-BE7A-99CD205A5F62}" dt="2025-11-27T11:14:07.172" v="70" actId="1038"/>
          <ac:spMkLst>
            <pc:docMk/>
            <pc:sldMk cId="3892590946" sldId="256"/>
            <ac:spMk id="10" creationId="{D3BF62CE-E884-4E14-BB97-21C524C6F8E4}"/>
          </ac:spMkLst>
        </pc:spChg>
        <pc:graphicFrameChg chg="mod">
          <ac:chgData name="Maxime GOLIAS" userId="1d0107c23b74f3ca" providerId="LiveId" clId="{8C31D4A3-5C85-4DFA-BE7A-99CD205A5F62}" dt="2025-11-27T11:13:11.546" v="45" actId="1076"/>
          <ac:graphicFrameMkLst>
            <pc:docMk/>
            <pc:sldMk cId="3892590946" sldId="256"/>
            <ac:graphicFrameMk id="4" creationId="{83ADF111-115D-44A1-993D-C2B2B39A6E8E}"/>
          </ac:graphicFrameMkLst>
        </pc:graphicFrameChg>
        <pc:picChg chg="mod">
          <ac:chgData name="Maxime GOLIAS" userId="1d0107c23b74f3ca" providerId="LiveId" clId="{8C31D4A3-5C85-4DFA-BE7A-99CD205A5F62}" dt="2025-11-27T11:12:45.860" v="34" actId="1036"/>
          <ac:picMkLst>
            <pc:docMk/>
            <pc:sldMk cId="3892590946" sldId="256"/>
            <ac:picMk id="5" creationId="{2352EAEF-7AE0-47AB-A7B8-F6517CF6598C}"/>
          </ac:picMkLst>
        </pc:picChg>
        <pc:picChg chg="mod">
          <ac:chgData name="Maxime GOLIAS" userId="1d0107c23b74f3ca" providerId="LiveId" clId="{8C31D4A3-5C85-4DFA-BE7A-99CD205A5F62}" dt="2025-11-27T11:12:55.232" v="38" actId="1037"/>
          <ac:picMkLst>
            <pc:docMk/>
            <pc:sldMk cId="3892590946" sldId="256"/>
            <ac:picMk id="11" creationId="{BD639333-ED38-4E76-854C-2A12DAA99476}"/>
          </ac:picMkLst>
        </pc:picChg>
      </pc:sldChg>
      <pc:sldChg chg="del">
        <pc:chgData name="Maxime GOLIAS" userId="1d0107c23b74f3ca" providerId="LiveId" clId="{8C31D4A3-5C85-4DFA-BE7A-99CD205A5F62}" dt="2025-11-27T11:11:46.405" v="3" actId="47"/>
        <pc:sldMkLst>
          <pc:docMk/>
          <pc:sldMk cId="3275609639" sldId="257"/>
        </pc:sldMkLst>
      </pc:sldChg>
    </pc:docChg>
  </pc:docChgLst>
  <pc:docChgLst>
    <pc:chgData name="Maxime GOLIAS" userId="1d0107c23b74f3ca" providerId="LiveId" clId="{3BABA733-38E0-4674-9EEF-2C9DD8D045F9}"/>
    <pc:docChg chg="custSel modSld">
      <pc:chgData name="Maxime GOLIAS" userId="1d0107c23b74f3ca" providerId="LiveId" clId="{3BABA733-38E0-4674-9EEF-2C9DD8D045F9}" dt="2025-06-19T15:53:17.977" v="45" actId="14100"/>
      <pc:docMkLst>
        <pc:docMk/>
      </pc:docMkLst>
      <pc:sldChg chg="modSp mod">
        <pc:chgData name="Maxime GOLIAS" userId="1d0107c23b74f3ca" providerId="LiveId" clId="{3BABA733-38E0-4674-9EEF-2C9DD8D045F9}" dt="2025-06-19T13:03:52.936" v="2" actId="20577"/>
        <pc:sldMkLst>
          <pc:docMk/>
          <pc:sldMk cId="3892590946" sldId="256"/>
        </pc:sldMkLst>
        <pc:spChg chg="mod">
          <ac:chgData name="Maxime GOLIAS" userId="1d0107c23b74f3ca" providerId="LiveId" clId="{3BABA733-38E0-4674-9EEF-2C9DD8D045F9}" dt="2025-06-19T13:03:40.094" v="0" actId="20577"/>
          <ac:spMkLst>
            <pc:docMk/>
            <pc:sldMk cId="3892590946" sldId="256"/>
            <ac:spMk id="2" creationId="{CAD8B20A-28B9-4A9D-BE62-1C3A9CE9FFB2}"/>
          </ac:spMkLst>
        </pc:spChg>
        <pc:spChg chg="mod">
          <ac:chgData name="Maxime GOLIAS" userId="1d0107c23b74f3ca" providerId="LiveId" clId="{3BABA733-38E0-4674-9EEF-2C9DD8D045F9}" dt="2025-06-19T13:03:50.920" v="1" actId="20577"/>
          <ac:spMkLst>
            <pc:docMk/>
            <pc:sldMk cId="3892590946" sldId="256"/>
            <ac:spMk id="6" creationId="{1246733A-404E-4BD2-B29E-642B643F394C}"/>
          </ac:spMkLst>
        </pc:spChg>
        <pc:spChg chg="mod">
          <ac:chgData name="Maxime GOLIAS" userId="1d0107c23b74f3ca" providerId="LiveId" clId="{3BABA733-38E0-4674-9EEF-2C9DD8D045F9}" dt="2025-06-19T13:03:52.936" v="2" actId="20577"/>
          <ac:spMkLst>
            <pc:docMk/>
            <pc:sldMk cId="3892590946" sldId="256"/>
            <ac:spMk id="9" creationId="{0346B0A7-A77F-460C-BD63-556881882CCE}"/>
          </ac:spMkLst>
        </pc:spChg>
      </pc:sldChg>
      <pc:sldChg chg="addSp delSp modSp mod">
        <pc:chgData name="Maxime GOLIAS" userId="1d0107c23b74f3ca" providerId="LiveId" clId="{3BABA733-38E0-4674-9EEF-2C9DD8D045F9}" dt="2025-06-19T15:53:17.977" v="45" actId="14100"/>
        <pc:sldMkLst>
          <pc:docMk/>
          <pc:sldMk cId="3275609639" sldId="257"/>
        </pc:sldMkLst>
        <pc:spChg chg="del">
          <ac:chgData name="Maxime GOLIAS" userId="1d0107c23b74f3ca" providerId="LiveId" clId="{3BABA733-38E0-4674-9EEF-2C9DD8D045F9}" dt="2025-06-19T13:06:38.107" v="9" actId="478"/>
          <ac:spMkLst>
            <pc:docMk/>
            <pc:sldMk cId="3275609639" sldId="257"/>
            <ac:spMk id="3" creationId="{929D990B-C45A-47D2-91BE-93ED3CCF4D6C}"/>
          </ac:spMkLst>
        </pc:spChg>
        <pc:spChg chg="add mod">
          <ac:chgData name="Maxime GOLIAS" userId="1d0107c23b74f3ca" providerId="LiveId" clId="{3BABA733-38E0-4674-9EEF-2C9DD8D045F9}" dt="2025-06-19T13:07:23.557" v="27" actId="20577"/>
          <ac:spMkLst>
            <pc:docMk/>
            <pc:sldMk cId="3275609639" sldId="257"/>
            <ac:spMk id="6" creationId="{79CEAC27-B9A0-4B64-A818-6B4817129DB7}"/>
          </ac:spMkLst>
        </pc:spChg>
        <pc:picChg chg="mod ord">
          <ac:chgData name="Maxime GOLIAS" userId="1d0107c23b74f3ca" providerId="LiveId" clId="{3BABA733-38E0-4674-9EEF-2C9DD8D045F9}" dt="2025-06-19T15:53:17.977" v="45" actId="14100"/>
          <ac:picMkLst>
            <pc:docMk/>
            <pc:sldMk cId="3275609639" sldId="257"/>
            <ac:picMk id="2" creationId="{5D8B34AF-DEF7-4193-A260-513889B2AF13}"/>
          </ac:picMkLst>
        </pc:picChg>
        <pc:picChg chg="del">
          <ac:chgData name="Maxime GOLIAS" userId="1d0107c23b74f3ca" providerId="LiveId" clId="{3BABA733-38E0-4674-9EEF-2C9DD8D045F9}" dt="2025-06-19T13:03:58.873" v="3" actId="478"/>
          <ac:picMkLst>
            <pc:docMk/>
            <pc:sldMk cId="3275609639" sldId="257"/>
            <ac:picMk id="4" creationId="{C8C94F3E-7EDB-42D6-83BE-B8CD31DD8847}"/>
          </ac:picMkLst>
        </pc:pic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50996" y="647957"/>
            <a:ext cx="3977958" cy="1378397"/>
          </a:xfrm>
        </p:spPr>
        <p:txBody>
          <a:bodyPr anchor="b"/>
          <a:lstStyle>
            <a:lvl1pPr algn="ctr">
              <a:defRPr sz="3071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84994" y="2079510"/>
            <a:ext cx="3509963" cy="955896"/>
          </a:xfrm>
        </p:spPr>
        <p:txBody>
          <a:bodyPr/>
          <a:lstStyle>
            <a:lvl1pPr marL="0" indent="0" algn="ctr">
              <a:buNone/>
              <a:defRPr sz="1228"/>
            </a:lvl1pPr>
            <a:lvl2pPr marL="233995" indent="0" algn="ctr">
              <a:buNone/>
              <a:defRPr sz="1024"/>
            </a:lvl2pPr>
            <a:lvl3pPr marL="467990" indent="0" algn="ctr">
              <a:buNone/>
              <a:defRPr sz="921"/>
            </a:lvl3pPr>
            <a:lvl4pPr marL="701985" indent="0" algn="ctr">
              <a:buNone/>
              <a:defRPr sz="819"/>
            </a:lvl4pPr>
            <a:lvl5pPr marL="935980" indent="0" algn="ctr">
              <a:buNone/>
              <a:defRPr sz="819"/>
            </a:lvl5pPr>
            <a:lvl6pPr marL="1169975" indent="0" algn="ctr">
              <a:buNone/>
              <a:defRPr sz="819"/>
            </a:lvl6pPr>
            <a:lvl7pPr marL="1403970" indent="0" algn="ctr">
              <a:buNone/>
              <a:defRPr sz="819"/>
            </a:lvl7pPr>
            <a:lvl8pPr marL="1637965" indent="0" algn="ctr">
              <a:buNone/>
              <a:defRPr sz="819"/>
            </a:lvl8pPr>
            <a:lvl9pPr marL="1871960" indent="0" algn="ctr">
              <a:buNone/>
              <a:defRPr sz="819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1031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1501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49090" y="210792"/>
            <a:ext cx="1009114" cy="3355260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1747" y="210792"/>
            <a:ext cx="2968843" cy="335526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5670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3829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9309" y="987058"/>
            <a:ext cx="4036457" cy="1646927"/>
          </a:xfrm>
        </p:spPr>
        <p:txBody>
          <a:bodyPr anchor="b"/>
          <a:lstStyle>
            <a:lvl1pPr>
              <a:defRPr sz="3071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9309" y="2649566"/>
            <a:ext cx="4036457" cy="866080"/>
          </a:xfrm>
        </p:spPr>
        <p:txBody>
          <a:bodyPr/>
          <a:lstStyle>
            <a:lvl1pPr marL="0" indent="0">
              <a:buNone/>
              <a:defRPr sz="1228">
                <a:solidFill>
                  <a:schemeClr val="tx1"/>
                </a:solidFill>
              </a:defRPr>
            </a:lvl1pPr>
            <a:lvl2pPr marL="233995" indent="0">
              <a:buNone/>
              <a:defRPr sz="1024">
                <a:solidFill>
                  <a:schemeClr val="tx1">
                    <a:tint val="75000"/>
                  </a:schemeClr>
                </a:solidFill>
              </a:defRPr>
            </a:lvl2pPr>
            <a:lvl3pPr marL="467990" indent="0">
              <a:buNone/>
              <a:defRPr sz="921">
                <a:solidFill>
                  <a:schemeClr val="tx1">
                    <a:tint val="75000"/>
                  </a:schemeClr>
                </a:solidFill>
              </a:defRPr>
            </a:lvl3pPr>
            <a:lvl4pPr marL="701985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4pPr>
            <a:lvl5pPr marL="935980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5pPr>
            <a:lvl6pPr marL="1169975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6pPr>
            <a:lvl7pPr marL="1403970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7pPr>
            <a:lvl8pPr marL="1637965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8pPr>
            <a:lvl9pPr marL="1871960" indent="0">
              <a:buNone/>
              <a:defRPr sz="8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2711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1746" y="1053960"/>
            <a:ext cx="1988979" cy="251209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69225" y="1053960"/>
            <a:ext cx="1988979" cy="251209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4527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210793"/>
            <a:ext cx="4036457" cy="76526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2357" y="970560"/>
            <a:ext cx="1979838" cy="475657"/>
          </a:xfrm>
        </p:spPr>
        <p:txBody>
          <a:bodyPr anchor="b"/>
          <a:lstStyle>
            <a:lvl1pPr marL="0" indent="0">
              <a:buNone/>
              <a:defRPr sz="1228" b="1"/>
            </a:lvl1pPr>
            <a:lvl2pPr marL="233995" indent="0">
              <a:buNone/>
              <a:defRPr sz="1024" b="1"/>
            </a:lvl2pPr>
            <a:lvl3pPr marL="467990" indent="0">
              <a:buNone/>
              <a:defRPr sz="921" b="1"/>
            </a:lvl3pPr>
            <a:lvl4pPr marL="701985" indent="0">
              <a:buNone/>
              <a:defRPr sz="819" b="1"/>
            </a:lvl4pPr>
            <a:lvl5pPr marL="935980" indent="0">
              <a:buNone/>
              <a:defRPr sz="819" b="1"/>
            </a:lvl5pPr>
            <a:lvl6pPr marL="1169975" indent="0">
              <a:buNone/>
              <a:defRPr sz="819" b="1"/>
            </a:lvl6pPr>
            <a:lvl7pPr marL="1403970" indent="0">
              <a:buNone/>
              <a:defRPr sz="819" b="1"/>
            </a:lvl7pPr>
            <a:lvl8pPr marL="1637965" indent="0">
              <a:buNone/>
              <a:defRPr sz="819" b="1"/>
            </a:lvl8pPr>
            <a:lvl9pPr marL="1871960" indent="0">
              <a:buNone/>
              <a:defRPr sz="819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2357" y="1446217"/>
            <a:ext cx="1979838" cy="212716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69225" y="970560"/>
            <a:ext cx="1989588" cy="475657"/>
          </a:xfrm>
        </p:spPr>
        <p:txBody>
          <a:bodyPr anchor="b"/>
          <a:lstStyle>
            <a:lvl1pPr marL="0" indent="0">
              <a:buNone/>
              <a:defRPr sz="1228" b="1"/>
            </a:lvl1pPr>
            <a:lvl2pPr marL="233995" indent="0">
              <a:buNone/>
              <a:defRPr sz="1024" b="1"/>
            </a:lvl2pPr>
            <a:lvl3pPr marL="467990" indent="0">
              <a:buNone/>
              <a:defRPr sz="921" b="1"/>
            </a:lvl3pPr>
            <a:lvl4pPr marL="701985" indent="0">
              <a:buNone/>
              <a:defRPr sz="819" b="1"/>
            </a:lvl4pPr>
            <a:lvl5pPr marL="935980" indent="0">
              <a:buNone/>
              <a:defRPr sz="819" b="1"/>
            </a:lvl5pPr>
            <a:lvl6pPr marL="1169975" indent="0">
              <a:buNone/>
              <a:defRPr sz="819" b="1"/>
            </a:lvl6pPr>
            <a:lvl7pPr marL="1403970" indent="0">
              <a:buNone/>
              <a:defRPr sz="819" b="1"/>
            </a:lvl7pPr>
            <a:lvl8pPr marL="1637965" indent="0">
              <a:buNone/>
              <a:defRPr sz="819" b="1"/>
            </a:lvl8pPr>
            <a:lvl9pPr marL="1871960" indent="0">
              <a:buNone/>
              <a:defRPr sz="819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69225" y="1446217"/>
            <a:ext cx="1989588" cy="212716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233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0642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0985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263948"/>
            <a:ext cx="1509406" cy="923819"/>
          </a:xfrm>
        </p:spPr>
        <p:txBody>
          <a:bodyPr anchor="b"/>
          <a:lstStyle>
            <a:lvl1pPr>
              <a:defRPr sz="1638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89588" y="570056"/>
            <a:ext cx="2369225" cy="2813616"/>
          </a:xfrm>
        </p:spPr>
        <p:txBody>
          <a:bodyPr/>
          <a:lstStyle>
            <a:lvl1pPr>
              <a:defRPr sz="1638"/>
            </a:lvl1pPr>
            <a:lvl2pPr>
              <a:defRPr sz="1433"/>
            </a:lvl2pPr>
            <a:lvl3pPr>
              <a:defRPr sz="1228"/>
            </a:lvl3pPr>
            <a:lvl4pPr>
              <a:defRPr sz="1024"/>
            </a:lvl4pPr>
            <a:lvl5pPr>
              <a:defRPr sz="1024"/>
            </a:lvl5pPr>
            <a:lvl6pPr>
              <a:defRPr sz="1024"/>
            </a:lvl6pPr>
            <a:lvl7pPr>
              <a:defRPr sz="1024"/>
            </a:lvl7pPr>
            <a:lvl8pPr>
              <a:defRPr sz="1024"/>
            </a:lvl8pPr>
            <a:lvl9pPr>
              <a:defRPr sz="1024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1187768"/>
            <a:ext cx="1509406" cy="2200486"/>
          </a:xfrm>
        </p:spPr>
        <p:txBody>
          <a:bodyPr/>
          <a:lstStyle>
            <a:lvl1pPr marL="0" indent="0">
              <a:buNone/>
              <a:defRPr sz="819"/>
            </a:lvl1pPr>
            <a:lvl2pPr marL="233995" indent="0">
              <a:buNone/>
              <a:defRPr sz="717"/>
            </a:lvl2pPr>
            <a:lvl3pPr marL="467990" indent="0">
              <a:buNone/>
              <a:defRPr sz="614"/>
            </a:lvl3pPr>
            <a:lvl4pPr marL="701985" indent="0">
              <a:buNone/>
              <a:defRPr sz="512"/>
            </a:lvl4pPr>
            <a:lvl5pPr marL="935980" indent="0">
              <a:buNone/>
              <a:defRPr sz="512"/>
            </a:lvl5pPr>
            <a:lvl6pPr marL="1169975" indent="0">
              <a:buNone/>
              <a:defRPr sz="512"/>
            </a:lvl6pPr>
            <a:lvl7pPr marL="1403970" indent="0">
              <a:buNone/>
              <a:defRPr sz="512"/>
            </a:lvl7pPr>
            <a:lvl8pPr marL="1637965" indent="0">
              <a:buNone/>
              <a:defRPr sz="512"/>
            </a:lvl8pPr>
            <a:lvl9pPr marL="1871960" indent="0">
              <a:buNone/>
              <a:defRPr sz="512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0183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263948"/>
            <a:ext cx="1509406" cy="923819"/>
          </a:xfrm>
        </p:spPr>
        <p:txBody>
          <a:bodyPr anchor="b"/>
          <a:lstStyle>
            <a:lvl1pPr>
              <a:defRPr sz="1638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89588" y="570056"/>
            <a:ext cx="2369225" cy="2813616"/>
          </a:xfrm>
        </p:spPr>
        <p:txBody>
          <a:bodyPr anchor="t"/>
          <a:lstStyle>
            <a:lvl1pPr marL="0" indent="0">
              <a:buNone/>
              <a:defRPr sz="1638"/>
            </a:lvl1pPr>
            <a:lvl2pPr marL="233995" indent="0">
              <a:buNone/>
              <a:defRPr sz="1433"/>
            </a:lvl2pPr>
            <a:lvl3pPr marL="467990" indent="0">
              <a:buNone/>
              <a:defRPr sz="1228"/>
            </a:lvl3pPr>
            <a:lvl4pPr marL="701985" indent="0">
              <a:buNone/>
              <a:defRPr sz="1024"/>
            </a:lvl4pPr>
            <a:lvl5pPr marL="935980" indent="0">
              <a:buNone/>
              <a:defRPr sz="1024"/>
            </a:lvl5pPr>
            <a:lvl6pPr marL="1169975" indent="0">
              <a:buNone/>
              <a:defRPr sz="1024"/>
            </a:lvl6pPr>
            <a:lvl7pPr marL="1403970" indent="0">
              <a:buNone/>
              <a:defRPr sz="1024"/>
            </a:lvl7pPr>
            <a:lvl8pPr marL="1637965" indent="0">
              <a:buNone/>
              <a:defRPr sz="1024"/>
            </a:lvl8pPr>
            <a:lvl9pPr marL="1871960" indent="0">
              <a:buNone/>
              <a:defRPr sz="1024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1187768"/>
            <a:ext cx="1509406" cy="2200486"/>
          </a:xfrm>
        </p:spPr>
        <p:txBody>
          <a:bodyPr/>
          <a:lstStyle>
            <a:lvl1pPr marL="0" indent="0">
              <a:buNone/>
              <a:defRPr sz="819"/>
            </a:lvl1pPr>
            <a:lvl2pPr marL="233995" indent="0">
              <a:buNone/>
              <a:defRPr sz="717"/>
            </a:lvl2pPr>
            <a:lvl3pPr marL="467990" indent="0">
              <a:buNone/>
              <a:defRPr sz="614"/>
            </a:lvl3pPr>
            <a:lvl4pPr marL="701985" indent="0">
              <a:buNone/>
              <a:defRPr sz="512"/>
            </a:lvl4pPr>
            <a:lvl5pPr marL="935980" indent="0">
              <a:buNone/>
              <a:defRPr sz="512"/>
            </a:lvl5pPr>
            <a:lvl6pPr marL="1169975" indent="0">
              <a:buNone/>
              <a:defRPr sz="512"/>
            </a:lvl6pPr>
            <a:lvl7pPr marL="1403970" indent="0">
              <a:buNone/>
              <a:defRPr sz="512"/>
            </a:lvl7pPr>
            <a:lvl8pPr marL="1637965" indent="0">
              <a:buNone/>
              <a:defRPr sz="512"/>
            </a:lvl8pPr>
            <a:lvl9pPr marL="1871960" indent="0">
              <a:buNone/>
              <a:defRPr sz="512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1507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1747" y="210793"/>
            <a:ext cx="4036457" cy="7652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1747" y="1053960"/>
            <a:ext cx="4036457" cy="25120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1746" y="3669616"/>
            <a:ext cx="1052989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4F7C8-D6E4-4FFF-8BED-C2CDDD237251}" type="datetimeFigureOut">
              <a:rPr lang="en-GB" smtClean="0"/>
              <a:t>2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50234" y="3669616"/>
            <a:ext cx="1579483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305215" y="3669616"/>
            <a:ext cx="1052989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3B474-E776-4039-8D58-12AA20EF0F2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3909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467990" rtl="0" eaLnBrk="1" latinLnBrk="0" hangingPunct="1">
        <a:lnSpc>
          <a:spcPct val="90000"/>
        </a:lnSpc>
        <a:spcBef>
          <a:spcPct val="0"/>
        </a:spcBef>
        <a:buNone/>
        <a:defRPr sz="22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6997" indent="-116997" algn="l" defTabSz="46799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433" kern="1200">
          <a:solidFill>
            <a:schemeClr val="tx1"/>
          </a:solidFill>
          <a:latin typeface="+mn-lt"/>
          <a:ea typeface="+mn-ea"/>
          <a:cs typeface="+mn-cs"/>
        </a:defRPr>
      </a:lvl1pPr>
      <a:lvl2pPr marL="350992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2pPr>
      <a:lvl3pPr marL="584987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1024" kern="1200">
          <a:solidFill>
            <a:schemeClr val="tx1"/>
          </a:solidFill>
          <a:latin typeface="+mn-lt"/>
          <a:ea typeface="+mn-ea"/>
          <a:cs typeface="+mn-cs"/>
        </a:defRPr>
      </a:lvl3pPr>
      <a:lvl4pPr marL="818982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1" kern="1200">
          <a:solidFill>
            <a:schemeClr val="tx1"/>
          </a:solidFill>
          <a:latin typeface="+mn-lt"/>
          <a:ea typeface="+mn-ea"/>
          <a:cs typeface="+mn-cs"/>
        </a:defRPr>
      </a:lvl4pPr>
      <a:lvl5pPr marL="1052977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1" kern="1200">
          <a:solidFill>
            <a:schemeClr val="tx1"/>
          </a:solidFill>
          <a:latin typeface="+mn-lt"/>
          <a:ea typeface="+mn-ea"/>
          <a:cs typeface="+mn-cs"/>
        </a:defRPr>
      </a:lvl5pPr>
      <a:lvl6pPr marL="1286972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1" kern="1200">
          <a:solidFill>
            <a:schemeClr val="tx1"/>
          </a:solidFill>
          <a:latin typeface="+mn-lt"/>
          <a:ea typeface="+mn-ea"/>
          <a:cs typeface="+mn-cs"/>
        </a:defRPr>
      </a:lvl6pPr>
      <a:lvl7pPr marL="1520967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1" kern="1200">
          <a:solidFill>
            <a:schemeClr val="tx1"/>
          </a:solidFill>
          <a:latin typeface="+mn-lt"/>
          <a:ea typeface="+mn-ea"/>
          <a:cs typeface="+mn-cs"/>
        </a:defRPr>
      </a:lvl7pPr>
      <a:lvl8pPr marL="1754962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1" kern="1200">
          <a:solidFill>
            <a:schemeClr val="tx1"/>
          </a:solidFill>
          <a:latin typeface="+mn-lt"/>
          <a:ea typeface="+mn-ea"/>
          <a:cs typeface="+mn-cs"/>
        </a:defRPr>
      </a:lvl8pPr>
      <a:lvl9pPr marL="1988957" indent="-116997" algn="l" defTabSz="467990" rtl="0" eaLnBrk="1" latinLnBrk="0" hangingPunct="1">
        <a:lnSpc>
          <a:spcPct val="90000"/>
        </a:lnSpc>
        <a:spcBef>
          <a:spcPts val="256"/>
        </a:spcBef>
        <a:buFont typeface="Arial" panose="020B0604020202020204" pitchFamily="34" charset="0"/>
        <a:buChar char="•"/>
        <a:defRPr sz="92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67990" rtl="0" eaLnBrk="1" latinLnBrk="0" hangingPunct="1">
        <a:defRPr sz="921" kern="1200">
          <a:solidFill>
            <a:schemeClr val="tx1"/>
          </a:solidFill>
          <a:latin typeface="+mn-lt"/>
          <a:ea typeface="+mn-ea"/>
          <a:cs typeface="+mn-cs"/>
        </a:defRPr>
      </a:lvl1pPr>
      <a:lvl2pPr marL="233995" algn="l" defTabSz="467990" rtl="0" eaLnBrk="1" latinLnBrk="0" hangingPunct="1">
        <a:defRPr sz="921" kern="1200">
          <a:solidFill>
            <a:schemeClr val="tx1"/>
          </a:solidFill>
          <a:latin typeface="+mn-lt"/>
          <a:ea typeface="+mn-ea"/>
          <a:cs typeface="+mn-cs"/>
        </a:defRPr>
      </a:lvl2pPr>
      <a:lvl3pPr marL="467990" algn="l" defTabSz="467990" rtl="0" eaLnBrk="1" latinLnBrk="0" hangingPunct="1">
        <a:defRPr sz="921" kern="1200">
          <a:solidFill>
            <a:schemeClr val="tx1"/>
          </a:solidFill>
          <a:latin typeface="+mn-lt"/>
          <a:ea typeface="+mn-ea"/>
          <a:cs typeface="+mn-cs"/>
        </a:defRPr>
      </a:lvl3pPr>
      <a:lvl4pPr marL="701985" algn="l" defTabSz="467990" rtl="0" eaLnBrk="1" latinLnBrk="0" hangingPunct="1">
        <a:defRPr sz="921" kern="1200">
          <a:solidFill>
            <a:schemeClr val="tx1"/>
          </a:solidFill>
          <a:latin typeface="+mn-lt"/>
          <a:ea typeface="+mn-ea"/>
          <a:cs typeface="+mn-cs"/>
        </a:defRPr>
      </a:lvl4pPr>
      <a:lvl5pPr marL="935980" algn="l" defTabSz="467990" rtl="0" eaLnBrk="1" latinLnBrk="0" hangingPunct="1">
        <a:defRPr sz="921" kern="1200">
          <a:solidFill>
            <a:schemeClr val="tx1"/>
          </a:solidFill>
          <a:latin typeface="+mn-lt"/>
          <a:ea typeface="+mn-ea"/>
          <a:cs typeface="+mn-cs"/>
        </a:defRPr>
      </a:lvl5pPr>
      <a:lvl6pPr marL="1169975" algn="l" defTabSz="467990" rtl="0" eaLnBrk="1" latinLnBrk="0" hangingPunct="1">
        <a:defRPr sz="921" kern="1200">
          <a:solidFill>
            <a:schemeClr val="tx1"/>
          </a:solidFill>
          <a:latin typeface="+mn-lt"/>
          <a:ea typeface="+mn-ea"/>
          <a:cs typeface="+mn-cs"/>
        </a:defRPr>
      </a:lvl6pPr>
      <a:lvl7pPr marL="1403970" algn="l" defTabSz="467990" rtl="0" eaLnBrk="1" latinLnBrk="0" hangingPunct="1">
        <a:defRPr sz="921" kern="1200">
          <a:solidFill>
            <a:schemeClr val="tx1"/>
          </a:solidFill>
          <a:latin typeface="+mn-lt"/>
          <a:ea typeface="+mn-ea"/>
          <a:cs typeface="+mn-cs"/>
        </a:defRPr>
      </a:lvl7pPr>
      <a:lvl8pPr marL="1637965" algn="l" defTabSz="467990" rtl="0" eaLnBrk="1" latinLnBrk="0" hangingPunct="1">
        <a:defRPr sz="921" kern="1200">
          <a:solidFill>
            <a:schemeClr val="tx1"/>
          </a:solidFill>
          <a:latin typeface="+mn-lt"/>
          <a:ea typeface="+mn-ea"/>
          <a:cs typeface="+mn-cs"/>
        </a:defRPr>
      </a:lvl8pPr>
      <a:lvl9pPr marL="1871960" algn="l" defTabSz="467990" rtl="0" eaLnBrk="1" latinLnBrk="0" hangingPunct="1">
        <a:defRPr sz="92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0">
            <a:extLst>
              <a:ext uri="{FF2B5EF4-FFF2-40B4-BE49-F238E27FC236}">
                <a16:creationId xmlns:a16="http://schemas.microsoft.com/office/drawing/2014/main" id="{BD639333-ED38-4E76-854C-2A12DAA9947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048"/>
          <a:stretch/>
        </p:blipFill>
        <p:spPr>
          <a:xfrm>
            <a:off x="2335032" y="4830"/>
            <a:ext cx="2335032" cy="1595125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2352EAEF-7AE0-47AB-A7B8-F6517CF6598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48" t="18836" r="22519" b="28810"/>
          <a:stretch/>
        </p:blipFill>
        <p:spPr>
          <a:xfrm>
            <a:off x="1" y="4943"/>
            <a:ext cx="2332573" cy="1593445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CAD8B20A-28B9-4A9D-BE62-1C3A9CE9FFB2}"/>
              </a:ext>
            </a:extLst>
          </p:cNvPr>
          <p:cNvSpPr txBox="1"/>
          <p:nvPr/>
        </p:nvSpPr>
        <p:spPr>
          <a:xfrm>
            <a:off x="-4916" y="0"/>
            <a:ext cx="5785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246733A-404E-4BD2-B29E-642B643F394C}"/>
              </a:ext>
            </a:extLst>
          </p:cNvPr>
          <p:cNvSpPr txBox="1"/>
          <p:nvPr/>
        </p:nvSpPr>
        <p:spPr>
          <a:xfrm>
            <a:off x="2332574" y="0"/>
            <a:ext cx="5785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83ADF111-115D-44A1-993D-C2B2B39A6E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5871615"/>
              </p:ext>
            </p:extLst>
          </p:nvPr>
        </p:nvGraphicFramePr>
        <p:xfrm>
          <a:off x="77665" y="1584250"/>
          <a:ext cx="1963946" cy="2360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5" imgW="2584334" imgH="3107409" progId="Prism8.Document">
                  <p:embed/>
                </p:oleObj>
              </mc:Choice>
              <mc:Fallback>
                <p:oleObj name="Prism 8" r:id="rId5" imgW="2584334" imgH="3107409" progId="Prism8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83ADF111-115D-44A1-993D-C2B2B39A6E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7665" y="1584250"/>
                        <a:ext cx="1963946" cy="2360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ZoneTexte 8">
            <a:extLst>
              <a:ext uri="{FF2B5EF4-FFF2-40B4-BE49-F238E27FC236}">
                <a16:creationId xmlns:a16="http://schemas.microsoft.com/office/drawing/2014/main" id="{0346B0A7-A77F-460C-BD63-556881882CCE}"/>
              </a:ext>
            </a:extLst>
          </p:cNvPr>
          <p:cNvSpPr txBox="1"/>
          <p:nvPr/>
        </p:nvSpPr>
        <p:spPr>
          <a:xfrm>
            <a:off x="-2457" y="1594906"/>
            <a:ext cx="5785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3BF62CE-E884-4E14-BB97-21C524C6F8E4}"/>
              </a:ext>
            </a:extLst>
          </p:cNvPr>
          <p:cNvSpPr txBox="1"/>
          <p:nvPr/>
        </p:nvSpPr>
        <p:spPr>
          <a:xfrm>
            <a:off x="2119275" y="1681633"/>
            <a:ext cx="2560675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000" b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 Figure. </a:t>
            </a:r>
            <a:r>
              <a:rPr lang="en-GB" sz="10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rocore collection and histological validation 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0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hotomicrograph of a microcore collected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om mouse liver (original magnification: X10)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Bar scale: 200 µm. (</a:t>
            </a:r>
            <a:r>
              <a:rPr lang="en-GB" sz="10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Microcore localization on tissue section of mouse liver analysed by haematoxylin and eosin staining. Diameter of 400 µm (200 µm inner diameter/2*100 µm needle wall) corresponding to the sampling area. Bar scale: 500 µm. (</a:t>
            </a:r>
            <a:r>
              <a:rPr lang="en-GB" sz="10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Size distribution of microcores collected.</a:t>
            </a:r>
            <a:endParaRPr lang="fr-FR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259094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A2448882D843F48852D3ABCD70D7C80" ma:contentTypeVersion="5" ma:contentTypeDescription="Crée un document." ma:contentTypeScope="" ma:versionID="b7f7e6289c4b1574f6a27f2feeb5e2a4">
  <xsd:schema xmlns:xsd="http://www.w3.org/2001/XMLSchema" xmlns:xs="http://www.w3.org/2001/XMLSchema" xmlns:p="http://schemas.microsoft.com/office/2006/metadata/properties" xmlns:ns3="b5fc9552-7f1a-43fc-8375-5392ac91bc38" targetNamespace="http://schemas.microsoft.com/office/2006/metadata/properties" ma:root="true" ma:fieldsID="1893b8683e7a29a50aa772cf5024f194" ns3:_="">
    <xsd:import namespace="b5fc9552-7f1a-43fc-8375-5392ac91bc3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5fc9552-7f1a-43fc-8375-5392ac91bc3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58842A6-75E6-45AD-A0E3-0C944B13A7CE}">
  <ds:schemaRefs>
    <ds:schemaRef ds:uri="http://schemas.microsoft.com/office/2006/documentManagement/types"/>
    <ds:schemaRef ds:uri="http://purl.org/dc/dcmitype/"/>
    <ds:schemaRef ds:uri="http://www.w3.org/XML/1998/namespace"/>
    <ds:schemaRef ds:uri="http://schemas.microsoft.com/office/2006/metadata/properties"/>
    <ds:schemaRef ds:uri="http://schemas.openxmlformats.org/package/2006/metadata/core-properties"/>
    <ds:schemaRef ds:uri="http://schemas.microsoft.com/office/infopath/2007/PartnerControls"/>
    <ds:schemaRef ds:uri="b5fc9552-7f1a-43fc-8375-5392ac91bc38"/>
    <ds:schemaRef ds:uri="http://purl.org/dc/terms/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DDB3C542-0779-4E71-BA56-434CFD3D49C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11CEEF4-6378-4F62-BB5D-D2AD8FF1D6E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5fc9552-7f1a-43fc-8375-5392ac91bc3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1</TotalTime>
  <Words>89</Words>
  <Application>Microsoft Office PowerPoint</Application>
  <PresentationFormat>Personnalisé</PresentationFormat>
  <Paragraphs>4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8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olias Maxime</dc:creator>
  <cp:lastModifiedBy>Heymann Dominique</cp:lastModifiedBy>
  <cp:revision>11</cp:revision>
  <dcterms:created xsi:type="dcterms:W3CDTF">2025-04-22T12:43:48Z</dcterms:created>
  <dcterms:modified xsi:type="dcterms:W3CDTF">2025-11-27T11:23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A2448882D843F48852D3ABCD70D7C80</vt:lpwstr>
  </property>
</Properties>
</file>